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79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8ADC0B-86AC-455E-A0D3-278C55DA34DB}" type="datetimeFigureOut">
              <a:rPr kumimoji="1" lang="ja-JP" altLang="en-US" smtClean="0"/>
              <a:t>2025/3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6BBEF2-6199-4662-9BC7-74C3298901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2448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/>
              <a:t>Figure 3. copy number plot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06BBEF2-6199-4662-9BC7-74C32989017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42494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1DBECBB-206B-4334-8BE4-7F72F943FBB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7389DE2-A2AC-4927-B3E4-7E787A407A0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7A0897A-6BDB-4776-854B-804B8D3B76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A93A90-2403-4766-A044-87F63BF063CB}" type="datetimeFigureOut">
              <a:rPr kumimoji="1" lang="ja-JP" altLang="en-US" smtClean="0"/>
              <a:t>2025/3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5F376C9-ABF0-4D9C-A5D7-FF0248E20A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6E20F6E-6DC8-4A82-B6E3-76E19AB70D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ADC6A-BBE2-4697-9EAB-09751BDF68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18176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59113B3-B7EC-43C5-970F-088D6D8519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AB3005E-3DEF-49C8-B029-608A6061B7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04DA095-A1FB-450B-BDC1-F6F5EA402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A93A90-2403-4766-A044-87F63BF063CB}" type="datetimeFigureOut">
              <a:rPr kumimoji="1" lang="ja-JP" altLang="en-US" smtClean="0"/>
              <a:t>2025/3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4857891-AFC0-46EC-B99B-C280569AA6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ACD42BB-127B-4C4F-B629-94BECC9A17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ADC6A-BBE2-4697-9EAB-09751BDF68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79186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67FCA99-D864-4CB9-BCF1-63BC93BBD46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D1DD212-27C4-453A-B5B2-734DF14DE2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71ABC73-7A74-4DB0-A45D-BE0544E2BD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A93A90-2403-4766-A044-87F63BF063CB}" type="datetimeFigureOut">
              <a:rPr kumimoji="1" lang="ja-JP" altLang="en-US" smtClean="0"/>
              <a:t>2025/3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4C58CB0-C8F9-435A-A33B-1744F8C24D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5E8C3A4-648D-4631-A1BE-ADB703113A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ADC6A-BBE2-4697-9EAB-09751BDF68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43000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BAA908A-0DAD-4F0C-B96B-FFF89CD7FB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6ACDD95-8716-4FB5-9093-BCE13D33A2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8BEDCEF-CDDB-4171-AE73-5D02D88DA6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A93A90-2403-4766-A044-87F63BF063CB}" type="datetimeFigureOut">
              <a:rPr kumimoji="1" lang="ja-JP" altLang="en-US" smtClean="0"/>
              <a:t>2025/3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D228097-A298-47AE-8142-715FDEDA50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3326354-0A54-487C-8B93-57120C6267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ADC6A-BBE2-4697-9EAB-09751BDF68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58876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51E175-B26A-4BA7-AAA5-4C9E5170C5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33E2D39-73DA-440B-8B4C-7A58600654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DFDAAB7-6335-4FFA-9920-799FDB7FB3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A93A90-2403-4766-A044-87F63BF063CB}" type="datetimeFigureOut">
              <a:rPr kumimoji="1" lang="ja-JP" altLang="en-US" smtClean="0"/>
              <a:t>2025/3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0D03FA7-AD34-4286-A976-95A85E631A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362244F-03B4-49DC-9B8B-E7C137197C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ADC6A-BBE2-4697-9EAB-09751BDF68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73627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99C7430-CE9B-404E-8796-79F3BB055D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7485AE4-8253-4CDC-BF38-41F017510F7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7AD15CC-BF0B-4794-A6BF-8AABAC937C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8B23802-3124-49D5-BCED-36479507D2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A93A90-2403-4766-A044-87F63BF063CB}" type="datetimeFigureOut">
              <a:rPr kumimoji="1" lang="ja-JP" altLang="en-US" smtClean="0"/>
              <a:t>2025/3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A8F5CB8-3625-4AAB-A394-8177C0D11F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656392A-1A8D-473E-A8F7-58374B8798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ADC6A-BBE2-4697-9EAB-09751BDF68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50269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B6AEC9-E985-4E11-9475-46F29F51D8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98E719E-50D3-4ED9-9540-BFBFE09ECF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260CD32-A6BE-4CC0-AFEB-AC34C0B4C1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94B16FD-31BC-46FA-BC32-4F9A64D02D8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1EA67DC-1AA1-4FBD-AE93-9EC76ACA179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530A368-47EF-438C-8580-96E43AADCA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A93A90-2403-4766-A044-87F63BF063CB}" type="datetimeFigureOut">
              <a:rPr kumimoji="1" lang="ja-JP" altLang="en-US" smtClean="0"/>
              <a:t>2025/3/1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65E68B6-7D51-424C-805F-B1CADD5BD2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E88B473-8628-4222-B444-82CE502DAF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ADC6A-BBE2-4697-9EAB-09751BDF68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48850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0892E08-95B2-4010-A271-E330D14F41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04381D6-B47A-407A-A29D-998A0DDB98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A93A90-2403-4766-A044-87F63BF063CB}" type="datetimeFigureOut">
              <a:rPr kumimoji="1" lang="ja-JP" altLang="en-US" smtClean="0"/>
              <a:t>2025/3/1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A221CAE-C201-4EFD-9A2C-E6C55C7AE0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73904B0-11EA-4736-9401-579E80B225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ADC6A-BBE2-4697-9EAB-09751BDF68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08939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5071BE9-AC33-4748-92E5-0DA79C1A13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A93A90-2403-4766-A044-87F63BF063CB}" type="datetimeFigureOut">
              <a:rPr kumimoji="1" lang="ja-JP" altLang="en-US" smtClean="0"/>
              <a:t>2025/3/1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8B8E641-D82C-4F5C-BF90-9850260FBE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E9D8C8F-31C8-45D8-A829-DA42ADDB62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ADC6A-BBE2-4697-9EAB-09751BDF68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56980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449E534-654B-4DA5-9172-CD61EB4C3B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2E1F3C0-9988-4EF2-BB7E-E1356108ECE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551F268-E549-46F2-B84A-260E4A8CD0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C9EA381-333C-4F9C-BE7A-80FAE8BB39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A93A90-2403-4766-A044-87F63BF063CB}" type="datetimeFigureOut">
              <a:rPr kumimoji="1" lang="ja-JP" altLang="en-US" smtClean="0"/>
              <a:t>2025/3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6764A1D-7669-42F2-9355-F5912E0C06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06E968E-CF9D-4C08-A062-26D1215312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ADC6A-BBE2-4697-9EAB-09751BDF68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86024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6CC4C47-8760-40F9-8D2C-7FE6D16324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3AF040AC-B02A-4425-AD2A-B796A3784FE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EAC162C-7957-45AC-8352-740172DB56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9108267-2A47-49E1-A08B-61D0B71370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A93A90-2403-4766-A044-87F63BF063CB}" type="datetimeFigureOut">
              <a:rPr kumimoji="1" lang="ja-JP" altLang="en-US" smtClean="0"/>
              <a:t>2025/3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A07F3DC-28AA-441F-A5A3-06E37226FB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71AB4CE-6095-42A0-A199-5A4A5DA905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ADC6A-BBE2-4697-9EAB-09751BDF68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5595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6DDC6B06-EFA0-4FE8-B63D-87EA18AF14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60E469C-6BC6-4933-B8EC-4CBD0AFDA8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0CA00F5-EA90-4923-A8FA-9ADF7141634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A93A90-2403-4766-A044-87F63BF063CB}" type="datetimeFigureOut">
              <a:rPr kumimoji="1" lang="ja-JP" altLang="en-US" smtClean="0"/>
              <a:t>2025/3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91AD5D4-24F4-44D4-82C6-1E462EDD47D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E90F2C8-C077-4754-90A5-410C4D7BCC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CADC6A-BBE2-4697-9EAB-09751BDF68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97244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60C1A5C8-0379-46A3-BC65-F4783AC5C0C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55453" y="0"/>
            <a:ext cx="6858000" cy="68580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E6EFF51-220D-4A74-8D51-751FA24C5E95}"/>
              </a:ext>
            </a:extLst>
          </p:cNvPr>
          <p:cNvSpPr txBox="1"/>
          <p:nvPr/>
        </p:nvSpPr>
        <p:spPr>
          <a:xfrm>
            <a:off x="2140892" y="5692032"/>
            <a:ext cx="8502315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kumimoji="1" lang="en-US" altLang="ja-JP">
                <a:latin typeface="Arial"/>
                <a:ea typeface="游ゴシック"/>
                <a:cs typeface="Arial"/>
              </a:rPr>
              <a:t>R</a:t>
            </a:r>
            <a:r>
              <a:rPr kumimoji="1" lang="en-US" altLang="ja-JP" baseline="30000">
                <a:latin typeface="Arial"/>
                <a:ea typeface="游ゴシック"/>
                <a:cs typeface="Arial"/>
              </a:rPr>
              <a:t>2</a:t>
            </a:r>
            <a:r>
              <a:rPr kumimoji="1" lang="ja-JP" altLang="en-US">
                <a:latin typeface="Arial"/>
                <a:ea typeface="游ゴシック"/>
                <a:cs typeface="Arial"/>
              </a:rPr>
              <a:t> </a:t>
            </a:r>
            <a:r>
              <a:rPr kumimoji="1" lang="en-US" altLang="ja-JP">
                <a:latin typeface="Arial"/>
                <a:ea typeface="游ゴシック"/>
                <a:cs typeface="Arial"/>
              </a:rPr>
              <a:t>= 0.994, 95%</a:t>
            </a:r>
            <a:r>
              <a:rPr lang="en-US" altLang="ja-JP">
                <a:latin typeface="Arial"/>
                <a:ea typeface="游ゴシック"/>
                <a:cs typeface="Arial"/>
              </a:rPr>
              <a:t> Confidential Interval:</a:t>
            </a:r>
            <a:r>
              <a:rPr kumimoji="1" lang="ja-JP" altLang="en-US">
                <a:latin typeface="Arial"/>
                <a:ea typeface="游ゴシック"/>
                <a:cs typeface="Arial"/>
              </a:rPr>
              <a:t> </a:t>
            </a:r>
            <a:r>
              <a:rPr kumimoji="1" lang="en-US" altLang="ja-JP">
                <a:latin typeface="Arial"/>
                <a:ea typeface="游ゴシック"/>
                <a:cs typeface="Arial"/>
              </a:rPr>
              <a:t>0.99-0.996, P</a:t>
            </a:r>
            <a:r>
              <a:rPr lang="en-US" altLang="ja-JP">
                <a:latin typeface="Arial"/>
                <a:ea typeface="游ゴシック"/>
                <a:cs typeface="Arial"/>
              </a:rPr>
              <a:t>-value</a:t>
            </a:r>
            <a:r>
              <a:rPr lang="ja-JP" altLang="en-US">
                <a:latin typeface="Arial"/>
                <a:ea typeface="游ゴシック"/>
                <a:cs typeface="Arial"/>
              </a:rPr>
              <a:t> &lt; 0.0001</a:t>
            </a:r>
            <a:r>
              <a:rPr lang="en-US" altLang="ja-JP">
                <a:latin typeface="Arial"/>
                <a:ea typeface="游ゴシック"/>
                <a:cs typeface="Arial"/>
              </a:rPr>
              <a:t> </a:t>
            </a:r>
            <a:endParaRPr lang="ja-JP" altLang="en-US">
              <a:latin typeface="Arial"/>
              <a:ea typeface="游ゴシック"/>
              <a:cs typeface="Arial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45623C4-FAAC-0DD4-2C04-DE6D98A9F75E}"/>
              </a:ext>
            </a:extLst>
          </p:cNvPr>
          <p:cNvSpPr txBox="1"/>
          <p:nvPr/>
        </p:nvSpPr>
        <p:spPr>
          <a:xfrm>
            <a:off x="2208362" y="6332711"/>
            <a:ext cx="91177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kern="100" dirty="0"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Supplemental Figure </a:t>
            </a:r>
            <a:r>
              <a:rPr lang="en-US" sz="1400" b="1" kern="100" dirty="0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1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. Copy number comparison between </a:t>
            </a:r>
            <a:r>
              <a:rPr lang="en-US" sz="1400" b="1" kern="100" dirty="0" err="1"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FoundationOne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sz="1400" b="1" kern="100" dirty="0" err="1"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CDx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and ACT </a:t>
            </a:r>
            <a:r>
              <a:rPr lang="en-US" sz="1400" b="1" kern="100" dirty="0" err="1"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Onco</a:t>
            </a:r>
            <a:r>
              <a:rPr lang="en-US" sz="1400" b="1" kern="100" dirty="0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+ assays. </a:t>
            </a:r>
            <a:endParaRPr lang="en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9E38357A-A7A2-C3EC-1809-8EF89A478A85}"/>
              </a:ext>
            </a:extLst>
          </p:cNvPr>
          <p:cNvSpPr/>
          <p:nvPr/>
        </p:nvSpPr>
        <p:spPr>
          <a:xfrm>
            <a:off x="5680364" y="4939145"/>
            <a:ext cx="1066800" cy="15932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B986B5DF-38E6-78CB-AC23-523F23885164}"/>
              </a:ext>
            </a:extLst>
          </p:cNvPr>
          <p:cNvSpPr/>
          <p:nvPr/>
        </p:nvSpPr>
        <p:spPr>
          <a:xfrm>
            <a:off x="5832764" y="5091545"/>
            <a:ext cx="1066800" cy="15932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C88A75F7-A5C9-DD7F-2002-40453264C265}"/>
              </a:ext>
            </a:extLst>
          </p:cNvPr>
          <p:cNvSpPr/>
          <p:nvPr/>
        </p:nvSpPr>
        <p:spPr>
          <a:xfrm rot="5233634">
            <a:off x="3096492" y="2570018"/>
            <a:ext cx="1066800" cy="15932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4099760-5143-2CA9-A9CC-AE06FAC6ED3E}"/>
              </a:ext>
            </a:extLst>
          </p:cNvPr>
          <p:cNvSpPr txBox="1"/>
          <p:nvPr/>
        </p:nvSpPr>
        <p:spPr>
          <a:xfrm>
            <a:off x="4619769" y="4842255"/>
            <a:ext cx="3544560" cy="276999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JP" sz="1200">
                <a:latin typeface="Arial"/>
                <a:cs typeface="Arial"/>
              </a:rPr>
              <a:t>Copy number measured by </a:t>
            </a:r>
            <a:r>
              <a:rPr lang="en-JP" sz="1200" err="1">
                <a:latin typeface="Arial"/>
                <a:cs typeface="Arial"/>
              </a:rPr>
              <a:t>FoundationOne</a:t>
            </a:r>
            <a:r>
              <a:rPr lang="en-JP" sz="1200">
                <a:latin typeface="Arial"/>
                <a:cs typeface="Arial"/>
              </a:rPr>
              <a:t> CDX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736F926-1647-489C-5E0A-B01CE7647F68}"/>
              </a:ext>
            </a:extLst>
          </p:cNvPr>
          <p:cNvSpPr txBox="1"/>
          <p:nvPr/>
        </p:nvSpPr>
        <p:spPr>
          <a:xfrm rot="16200000">
            <a:off x="2137874" y="2376834"/>
            <a:ext cx="2917786" cy="276999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JP" sz="1200">
                <a:latin typeface="Arial"/>
                <a:cs typeface="Arial"/>
              </a:rPr>
              <a:t>Copy number measured by ACT </a:t>
            </a:r>
            <a:r>
              <a:rPr lang="en-JP" sz="1200" err="1">
                <a:latin typeface="Arial"/>
                <a:cs typeface="Arial"/>
              </a:rPr>
              <a:t>Onco</a:t>
            </a:r>
            <a:r>
              <a:rPr lang="en-JP" sz="1200">
                <a:latin typeface="Arial"/>
                <a:cs typeface="Arial"/>
              </a:rPr>
              <a:t>+</a:t>
            </a:r>
          </a:p>
        </p:txBody>
      </p:sp>
    </p:spTree>
    <p:extLst>
      <p:ext uri="{BB962C8B-B14F-4D97-AF65-F5344CB8AC3E}">
        <p14:creationId xmlns:p14="http://schemas.microsoft.com/office/powerpoint/2010/main" val="32250957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55</Words>
  <Application>Microsoft Office PowerPoint</Application>
  <PresentationFormat>Widescreen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角田 龍太</dc:creator>
  <cp:lastModifiedBy>J.D. Brookbank</cp:lastModifiedBy>
  <cp:revision>5</cp:revision>
  <dcterms:created xsi:type="dcterms:W3CDTF">2023-05-13T01:45:02Z</dcterms:created>
  <dcterms:modified xsi:type="dcterms:W3CDTF">2025-03-10T14:47:12Z</dcterms:modified>
</cp:coreProperties>
</file>